
<file path=[Content_Types].xml><?xml version="1.0" encoding="utf-8"?>
<Types xmlns="http://schemas.openxmlformats.org/package/2006/content-types">
  <Default Extension="jpeg" ContentType="image/jpeg"/>
  <Default Extension="jp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napToObjects="1">
      <p:cViewPr varScale="1">
        <p:scale>
          <a:sx n="121" d="100"/>
          <a:sy n="121" d="100"/>
        </p:scale>
        <p:origin x="190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EAFFB-F998-7544-9923-E8E4D6FFDD6A}" type="datetimeFigureOut">
              <a:rPr lang="it-IT" smtClean="0"/>
              <a:t>02/06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1B814E-1375-E347-A523-53D6D37D49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60927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EAFFB-F998-7544-9923-E8E4D6FFDD6A}" type="datetimeFigureOut">
              <a:rPr lang="it-IT" smtClean="0"/>
              <a:t>02/06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1B814E-1375-E347-A523-53D6D37D49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82644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EAFFB-F998-7544-9923-E8E4D6FFDD6A}" type="datetimeFigureOut">
              <a:rPr lang="it-IT" smtClean="0"/>
              <a:t>02/06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1B814E-1375-E347-A523-53D6D37D49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144697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EAFFB-F998-7544-9923-E8E4D6FFDD6A}" type="datetimeFigureOut">
              <a:rPr lang="it-IT" smtClean="0"/>
              <a:t>02/06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1B814E-1375-E347-A523-53D6D37D49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222453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EAFFB-F998-7544-9923-E8E4D6FFDD6A}" type="datetimeFigureOut">
              <a:rPr lang="it-IT" smtClean="0"/>
              <a:t>02/06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1B814E-1375-E347-A523-53D6D37D49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844982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EAFFB-F998-7544-9923-E8E4D6FFDD6A}" type="datetimeFigureOut">
              <a:rPr lang="it-IT" smtClean="0"/>
              <a:t>02/06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1B814E-1375-E347-A523-53D6D37D49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91228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EAFFB-F998-7544-9923-E8E4D6FFDD6A}" type="datetimeFigureOut">
              <a:rPr lang="it-IT" smtClean="0"/>
              <a:t>02/06/22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1B814E-1375-E347-A523-53D6D37D49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8669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EAFFB-F998-7544-9923-E8E4D6FFDD6A}" type="datetimeFigureOut">
              <a:rPr lang="it-IT" smtClean="0"/>
              <a:t>02/06/22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1B814E-1375-E347-A523-53D6D37D49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080675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EAFFB-F998-7544-9923-E8E4D6FFDD6A}" type="datetimeFigureOut">
              <a:rPr lang="it-IT" smtClean="0"/>
              <a:t>02/06/22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1B814E-1375-E347-A523-53D6D37D49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1347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EAFFB-F998-7544-9923-E8E4D6FFDD6A}" type="datetimeFigureOut">
              <a:rPr lang="it-IT" smtClean="0"/>
              <a:t>02/06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1B814E-1375-E347-A523-53D6D37D49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793895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EAFFB-F998-7544-9923-E8E4D6FFDD6A}" type="datetimeFigureOut">
              <a:rPr lang="it-IT" smtClean="0"/>
              <a:t>02/06/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1B814E-1375-E347-A523-53D6D37D49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20951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EAFFB-F998-7544-9923-E8E4D6FFDD6A}" type="datetimeFigureOut">
              <a:rPr lang="it-IT" smtClean="0"/>
              <a:t>02/06/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1B814E-1375-E347-A523-53D6D37D49E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888635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2.jp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Supplementary movie" descr="Supplementary movie">
            <a:hlinkClick r:id="" action="ppaction://media"/>
            <a:extLst>
              <a:ext uri="{FF2B5EF4-FFF2-40B4-BE49-F238E27FC236}">
                <a16:creationId xmlns:a16="http://schemas.microsoft.com/office/drawing/2014/main" id="{88115D1F-A451-F0FF-0E90-2DBC89D8076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194352" y="866347"/>
            <a:ext cx="5652991" cy="3768660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4E337E73-4173-D687-0D66-153B77B2F9EF}"/>
              </a:ext>
            </a:extLst>
          </p:cNvPr>
          <p:cNvSpPr txBox="1"/>
          <p:nvPr/>
        </p:nvSpPr>
        <p:spPr>
          <a:xfrm>
            <a:off x="52097" y="5529988"/>
            <a:ext cx="903980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Supplementary File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1.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Figure (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 and Movie (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 showing the apparatus used for the measurement of the phloem transport linear speed. Detector 1 acts as control: it allows to evaluate whether C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is inside the plant after the labelling. Detectors 2 and 3 are used for the data collection. </a:t>
            </a:r>
            <a:endParaRPr lang="it-IT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1D4BE335-6A45-2A78-79CB-507FDC65855E}"/>
              </a:ext>
            </a:extLst>
          </p:cNvPr>
          <p:cNvSpPr txBox="1"/>
          <p:nvPr/>
        </p:nvSpPr>
        <p:spPr>
          <a:xfrm>
            <a:off x="3194352" y="960936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" name="Gruppo 1">
            <a:extLst>
              <a:ext uri="{FF2B5EF4-FFF2-40B4-BE49-F238E27FC236}">
                <a16:creationId xmlns:a16="http://schemas.microsoft.com/office/drawing/2014/main" id="{5044E987-66AB-9A07-24DB-100A34D40ACF}"/>
              </a:ext>
            </a:extLst>
          </p:cNvPr>
          <p:cNvGrpSpPr/>
          <p:nvPr/>
        </p:nvGrpSpPr>
        <p:grpSpPr>
          <a:xfrm>
            <a:off x="135429" y="866346"/>
            <a:ext cx="2768313" cy="3768660"/>
            <a:chOff x="135429" y="866346"/>
            <a:chExt cx="2768313" cy="3768660"/>
          </a:xfrm>
        </p:grpSpPr>
        <p:pic>
          <p:nvPicPr>
            <p:cNvPr id="6" name="Immagine 5">
              <a:extLst>
                <a:ext uri="{FF2B5EF4-FFF2-40B4-BE49-F238E27FC236}">
                  <a16:creationId xmlns:a16="http://schemas.microsoft.com/office/drawing/2014/main" id="{CE471FB2-10D0-2148-A3C1-AA8F04E14C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12" t="3510" r="51621" b="54256"/>
            <a:stretch/>
          </p:blipFill>
          <p:spPr bwMode="auto">
            <a:xfrm>
              <a:off x="135429" y="866346"/>
              <a:ext cx="2768313" cy="3768660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8D726256-FBC0-30AE-A0B7-D88F93129E2A}"/>
                </a:ext>
              </a:extLst>
            </p:cNvPr>
            <p:cNvSpPr txBox="1"/>
            <p:nvPr/>
          </p:nvSpPr>
          <p:spPr>
            <a:xfrm>
              <a:off x="296657" y="950426"/>
              <a:ext cx="327334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it-IT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1117664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6828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60</Words>
  <Application>Microsoft Macintosh PowerPoint</Application>
  <PresentationFormat>Presentazione su schermo (4:3)</PresentationFormat>
  <Paragraphs>3</Paragraphs>
  <Slides>1</Slides>
  <Notes>0</Notes>
  <HiddenSlides>0</HiddenSlides>
  <MMClips>1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usetti Rita</dc:creator>
  <cp:lastModifiedBy>Musetti Rita</cp:lastModifiedBy>
  <cp:revision>9</cp:revision>
  <dcterms:created xsi:type="dcterms:W3CDTF">2022-05-22T15:44:39Z</dcterms:created>
  <dcterms:modified xsi:type="dcterms:W3CDTF">2022-06-02T14:08:15Z</dcterms:modified>
</cp:coreProperties>
</file>